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322" r:id="rId2"/>
    <p:sldId id="323" r:id="rId3"/>
    <p:sldId id="324" r:id="rId4"/>
    <p:sldId id="327" r:id="rId5"/>
    <p:sldId id="328" r:id="rId6"/>
    <p:sldId id="329" r:id="rId7"/>
    <p:sldId id="331" r:id="rId8"/>
    <p:sldId id="332" r:id="rId9"/>
    <p:sldId id="333" r:id="rId10"/>
    <p:sldId id="335" r:id="rId11"/>
    <p:sldId id="336" r:id="rId12"/>
    <p:sldId id="337" r:id="rId13"/>
  </p:sldIdLst>
  <p:sldSz cx="12192000" cy="6858000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ox9" id="{7798565D-D37D-403C-85EE-230B228681C2}">
          <p14:sldIdLst>
            <p14:sldId id="322"/>
            <p14:sldId id="323"/>
            <p14:sldId id="324"/>
            <p14:sldId id="327"/>
            <p14:sldId id="328"/>
            <p14:sldId id="329"/>
            <p14:sldId id="331"/>
            <p14:sldId id="332"/>
            <p14:sldId id="333"/>
            <p14:sldId id="335"/>
            <p14:sldId id="336"/>
            <p14:sldId id="33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66FF66"/>
    <a:srgbClr val="0000FF"/>
    <a:srgbClr val="660066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5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B9080A-22D4-4E65-B7B9-39A696BC83A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0F0D5C-F0BE-4579-B8FA-4B38396F66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8866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3D12A4-3267-5DAD-02D5-E8A28667B2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CB51BB1-7A9A-E4EB-7775-96F9C24BEC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C7852C4-1609-11B8-B038-F40F5297D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1B3584D-C1C4-41DF-F72C-7FE7BE535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152190D-81BB-C6D5-D53F-B471EA039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7844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1EA5D4B-4E26-C09F-30A9-4BA3DC957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22C44E0-3C3D-01D5-1951-05935917A7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0D82BF3-AEC5-4261-912C-E2A3AFA9A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A3862D0-BFF0-2A0C-3B8F-9DF0F1FBD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353481D-6F24-9B16-08F1-4A7286BF9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4090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C1C7FE6-67CE-2A6B-A025-B8C6041063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0B3BC21-9542-F9EB-50E2-06AEF948AA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4FA7530-C3EA-E6FE-03F4-DE1C22022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DC6C17B-4967-6AD4-C404-BDE5F2F7C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7086EB-B39E-D617-DFA1-22F81E96E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3553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B65BC93-C622-D564-04DD-3163BBD7D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2A612A2-2E46-0BCD-2077-96DCFFD645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83E7396-00CC-5B92-249C-F76CC2B54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D5A7E3-7546-B85A-1A45-35F289EC1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45CBF0-6838-7ECD-6405-90A0605CA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8004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B8322F-A99D-690C-2A9B-68B1B7D655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8B6897E-F0EA-54D7-EA21-571409B6EA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562CFC2-EC8F-B441-68FF-0C9BF15A2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390CFCF-161D-1A2B-72E4-BDBD9A094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E185F04-CFD7-6325-1817-D755A0BC6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8129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80CF781-F85A-8443-1717-B31324100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44D7D18-3C16-5D84-6DD4-971B8CA307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AA3DFEE-E81F-CF72-8419-B2DAFA304A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EE8858D-5659-8A3A-6348-DFE11FE8B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DF3DE3C-B049-F1E3-E952-1E83636CA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93AB55-34C1-164E-B52C-1F70927E9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1690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4B1E37D-AB08-682C-E3FB-86CBA21AA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50C261A-849B-B880-CFB3-07A74989A8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B8A2E2E-2C89-A54B-8EE1-5D47998BA7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A7042FB-BAAE-55B9-3864-09D1481DEC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D955BEC1-6918-FF9C-BDB5-EF447130B0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7075CA7-7D1D-0872-4618-005D16C24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CE86C5E-AEE4-1554-9775-186832C79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4AACFB6-530D-78CF-944B-692A5883C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1059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5D9D4C1-E14A-E071-E35A-C9A5A601D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FF99B3F-76A3-728E-6CD2-F9D8A2061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BB0CF3D-8F73-2FAA-3C80-9C0657721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0C36175-0DB2-1CDD-6DF3-F07F820486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4891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05B5273-4803-4716-BF65-5952FF52C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07A1F32-2021-BE90-32A0-3A60F0BFB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EE69514-86F6-F51A-8467-636BF06C8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6937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D1C15C-6622-5767-3B64-787E4C2F3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52B222B-E15A-462D-4894-FA4F54AEBD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C798036-B180-8ECE-E1B0-5E4E2FA052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F7BC784-B303-20FF-1C1C-D5ACB648E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A6F4FED-69DD-36E4-47D7-5EAF5FAD6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F2AA193-4999-81BC-D14A-F28393A31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730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9B018E-DA39-20A1-5571-94E70F92E5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8298254-777C-4E4A-986B-C01FAECCD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D824D90-CBF9-8119-C67B-C73AC2C826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AEAE09A-207F-CCC0-6FBD-A1077A3C7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08967FB-85C0-D6DF-7EE9-AC7840C01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506107B-79FC-2318-7621-D80A4B520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028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50AF970-6586-E37F-933C-24995F8E7B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233B9C3-9843-4D2C-B90A-C10558C11A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1C3C4D9-E6BD-406F-F70D-81C3EF5B5B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397B7D-4F1E-BC1A-F721-309E4B82EA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FCC8A4-8EDF-20B3-9BE4-8D8E6CC1D0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2804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>
            <a:extLst>
              <a:ext uri="{FF2B5EF4-FFF2-40B4-BE49-F238E27FC236}">
                <a16:creationId xmlns:a16="http://schemas.microsoft.com/office/drawing/2014/main" id="{7CA5D524-D1C4-89DA-E187-14EE6A9E64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085681">
            <a:off x="2514185" y="469902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A041468-E3C9-FDD7-CC69-81426BDB8212}"/>
              </a:ext>
            </a:extLst>
          </p:cNvPr>
          <p:cNvSpPr txBox="1"/>
          <p:nvPr/>
        </p:nvSpPr>
        <p:spPr>
          <a:xfrm>
            <a:off x="0" y="0"/>
            <a:ext cx="19474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24612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E1329392-D4DE-2CE9-5A1E-01DE4A2886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3426651">
            <a:off x="3384136" y="85722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913521" y="1058766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88E37FE-C22B-16AB-6626-B6E005F69F15}"/>
              </a:ext>
            </a:extLst>
          </p:cNvPr>
          <p:cNvSpPr txBox="1"/>
          <p:nvPr/>
        </p:nvSpPr>
        <p:spPr>
          <a:xfrm>
            <a:off x="-437791" y="0"/>
            <a:ext cx="27410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+Dlx2miR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28690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CF44F1C1-1481-FF11-B2DA-1CEAD05434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3426651">
            <a:off x="3384136" y="85722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913521" y="1058766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1CD0ADC-8C48-085D-E0A1-DE468BB9D5D1}"/>
              </a:ext>
            </a:extLst>
          </p:cNvPr>
          <p:cNvSpPr txBox="1"/>
          <p:nvPr/>
        </p:nvSpPr>
        <p:spPr>
          <a:xfrm>
            <a:off x="-437791" y="0"/>
            <a:ext cx="27410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+Dlx2miR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4014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079CB500-5C2F-0797-D093-087F21E19D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3426651">
            <a:off x="3384136" y="85722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913521" y="1058766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D774FA4-8A8B-27C5-2627-8F9A6E54B396}"/>
              </a:ext>
            </a:extLst>
          </p:cNvPr>
          <p:cNvSpPr txBox="1"/>
          <p:nvPr/>
        </p:nvSpPr>
        <p:spPr>
          <a:xfrm>
            <a:off x="-437791" y="0"/>
            <a:ext cx="27410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+Dlx2miR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2891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그림 15">
            <a:extLst>
              <a:ext uri="{FF2B5EF4-FFF2-40B4-BE49-F238E27FC236}">
                <a16:creationId xmlns:a16="http://schemas.microsoft.com/office/drawing/2014/main" id="{34B32753-0F64-5079-99E8-2C6080DFC4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085681">
            <a:off x="2514185" y="469902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A59B9A5-9276-0E36-9030-1038C0D4AFA9}"/>
              </a:ext>
            </a:extLst>
          </p:cNvPr>
          <p:cNvSpPr txBox="1"/>
          <p:nvPr/>
        </p:nvSpPr>
        <p:spPr>
          <a:xfrm>
            <a:off x="0" y="0"/>
            <a:ext cx="19474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444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그림 17">
            <a:extLst>
              <a:ext uri="{FF2B5EF4-FFF2-40B4-BE49-F238E27FC236}">
                <a16:creationId xmlns:a16="http://schemas.microsoft.com/office/drawing/2014/main" id="{061B3C2E-AF80-D380-381C-6666D36895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085681">
            <a:off x="2514185" y="469902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52BDF3A-1769-B9F5-345B-317CA982A329}"/>
              </a:ext>
            </a:extLst>
          </p:cNvPr>
          <p:cNvSpPr txBox="1"/>
          <p:nvPr/>
        </p:nvSpPr>
        <p:spPr>
          <a:xfrm>
            <a:off x="0" y="0"/>
            <a:ext cx="19474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62659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B9C45A73-E3ED-4E8F-F0AD-FD6A0B2D41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582451">
            <a:off x="3429266" y="743231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A3EE51C-0F62-548B-0DBF-2329D73B4691}"/>
              </a:ext>
            </a:extLst>
          </p:cNvPr>
          <p:cNvSpPr txBox="1"/>
          <p:nvPr/>
        </p:nvSpPr>
        <p:spPr>
          <a:xfrm>
            <a:off x="0" y="0"/>
            <a:ext cx="19474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+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88998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72444B15-F6B4-61BB-48A8-4E6E90E065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577288">
            <a:off x="3430399" y="742044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42CA12B-0926-2011-4A43-42E66EF351D2}"/>
              </a:ext>
            </a:extLst>
          </p:cNvPr>
          <p:cNvSpPr txBox="1"/>
          <p:nvPr/>
        </p:nvSpPr>
        <p:spPr>
          <a:xfrm>
            <a:off x="0" y="0"/>
            <a:ext cx="19474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+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14694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8ABF8D24-6E68-26F3-2AF1-C52F97F24F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586509">
            <a:off x="3432429" y="744169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213D8B5-DFC3-225A-5C27-47AEBECB812C}"/>
              </a:ext>
            </a:extLst>
          </p:cNvPr>
          <p:cNvSpPr txBox="1"/>
          <p:nvPr/>
        </p:nvSpPr>
        <p:spPr>
          <a:xfrm>
            <a:off x="0" y="0"/>
            <a:ext cx="19474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+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01022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CDC93584-8609-823B-363C-E223B39225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218966">
            <a:off x="4136610" y="2295523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7BD3FC6-795D-0120-51C8-6272D89162E7}"/>
              </a:ext>
            </a:extLst>
          </p:cNvPr>
          <p:cNvSpPr txBox="1"/>
          <p:nvPr/>
        </p:nvSpPr>
        <p:spPr>
          <a:xfrm>
            <a:off x="-215660" y="0"/>
            <a:ext cx="23808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+Dlx2miR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6399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ED419049-F9D1-67AC-892A-C8D22EE2EE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218966">
            <a:off x="4136610" y="2295523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30E25B9-80EA-5C31-32F9-3C1557C3A115}"/>
              </a:ext>
            </a:extLst>
          </p:cNvPr>
          <p:cNvSpPr txBox="1"/>
          <p:nvPr/>
        </p:nvSpPr>
        <p:spPr>
          <a:xfrm>
            <a:off x="-215660" y="0"/>
            <a:ext cx="23808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+Dlx2miR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12630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A1B917F3-857B-AE76-4030-73DEE08D01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218966">
            <a:off x="4136610" y="2295523"/>
            <a:ext cx="6909629" cy="6858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5342020" y="2722465"/>
            <a:ext cx="1800000" cy="3600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781F056-C931-CDDE-C4F5-01D369765FE5}"/>
              </a:ext>
            </a:extLst>
          </p:cNvPr>
          <p:cNvSpPr txBox="1"/>
          <p:nvPr/>
        </p:nvSpPr>
        <p:spPr>
          <a:xfrm>
            <a:off x="-215660" y="0"/>
            <a:ext cx="23808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acZ+Dlx2miR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0858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30</Words>
  <Application>Microsoft Office PowerPoint</Application>
  <PresentationFormat>와이드스크린</PresentationFormat>
  <Paragraphs>12</Paragraphs>
  <Slides>1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15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17</cp:revision>
  <cp:lastPrinted>2023-03-22T06:29:27Z</cp:lastPrinted>
  <dcterms:created xsi:type="dcterms:W3CDTF">2022-08-01T11:36:47Z</dcterms:created>
  <dcterms:modified xsi:type="dcterms:W3CDTF">2024-09-30T06:51:54Z</dcterms:modified>
</cp:coreProperties>
</file>